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368AC-978F-4065-B57A-ACFFEFC3AAFC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4BEC-BDB2-407F-8031-4948FC7B85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88468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368AC-978F-4065-B57A-ACFFEFC3AAFC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4BEC-BDB2-407F-8031-4948FC7B85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7163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368AC-978F-4065-B57A-ACFFEFC3AAFC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4BEC-BDB2-407F-8031-4948FC7B85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57082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368AC-978F-4065-B57A-ACFFEFC3AAFC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4BEC-BDB2-407F-8031-4948FC7B85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9010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368AC-978F-4065-B57A-ACFFEFC3AAFC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4BEC-BDB2-407F-8031-4948FC7B85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5777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368AC-978F-4065-B57A-ACFFEFC3AAFC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4BEC-BDB2-407F-8031-4948FC7B85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1570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368AC-978F-4065-B57A-ACFFEFC3AAFC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4BEC-BDB2-407F-8031-4948FC7B85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8807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368AC-978F-4065-B57A-ACFFEFC3AAFC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4BEC-BDB2-407F-8031-4948FC7B85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6966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368AC-978F-4065-B57A-ACFFEFC3AAFC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4BEC-BDB2-407F-8031-4948FC7B85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071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368AC-978F-4065-B57A-ACFFEFC3AAFC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4BEC-BDB2-407F-8031-4948FC7B85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8595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368AC-978F-4065-B57A-ACFFEFC3AAFC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94BEC-BDB2-407F-8031-4948FC7B85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067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6368AC-978F-4065-B57A-ACFFEFC3AAFC}" type="datetimeFigureOut">
              <a:rPr lang="en-GB" smtClean="0"/>
              <a:t>24/02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94BEC-BDB2-407F-8031-4948FC7B8526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2265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8234"/>
          <a:stretch/>
        </p:blipFill>
        <p:spPr bwMode="auto">
          <a:xfrm>
            <a:off x="1207016" y="3000524"/>
            <a:ext cx="2781300" cy="19850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4497587" y="5026967"/>
            <a:ext cx="7315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5026315" y="5026967"/>
            <a:ext cx="7315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MP-9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555043" y="5026967"/>
            <a:ext cx="7315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6083772" y="4942329"/>
            <a:ext cx="73151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MP-9 +LPS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Gerade Verbindung 8"/>
          <p:cNvCxnSpPr/>
          <p:nvPr/>
        </p:nvCxnSpPr>
        <p:spPr>
          <a:xfrm flipV="1">
            <a:off x="3573754" y="3432572"/>
            <a:ext cx="0" cy="100811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9"/>
          <p:cNvCxnSpPr/>
          <p:nvPr/>
        </p:nvCxnSpPr>
        <p:spPr>
          <a:xfrm flipH="1">
            <a:off x="3203452" y="3423336"/>
            <a:ext cx="3798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feld 10"/>
          <p:cNvSpPr txBox="1"/>
          <p:nvPr/>
        </p:nvSpPr>
        <p:spPr>
          <a:xfrm>
            <a:off x="3177060" y="3186013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*</a:t>
            </a:r>
            <a:endParaRPr lang="en-GB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6292"/>
          <a:stretch/>
        </p:blipFill>
        <p:spPr bwMode="auto">
          <a:xfrm>
            <a:off x="4087336" y="2968052"/>
            <a:ext cx="2788920" cy="20500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4" name="Gerade Verbindung 13"/>
          <p:cNvCxnSpPr/>
          <p:nvPr/>
        </p:nvCxnSpPr>
        <p:spPr>
          <a:xfrm flipV="1">
            <a:off x="4863345" y="3409996"/>
            <a:ext cx="0" cy="110560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15"/>
          <p:cNvCxnSpPr/>
          <p:nvPr/>
        </p:nvCxnSpPr>
        <p:spPr>
          <a:xfrm flipH="1">
            <a:off x="4863345" y="3993071"/>
            <a:ext cx="105745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18"/>
          <p:cNvCxnSpPr/>
          <p:nvPr/>
        </p:nvCxnSpPr>
        <p:spPr>
          <a:xfrm flipV="1">
            <a:off x="5911565" y="3983835"/>
            <a:ext cx="0" cy="288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16"/>
          <p:cNvSpPr txBox="1"/>
          <p:nvPr/>
        </p:nvSpPr>
        <p:spPr>
          <a:xfrm>
            <a:off x="5167456" y="3770036"/>
            <a:ext cx="528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*</a:t>
            </a:r>
            <a:endParaRPr lang="en-GB" dirty="0"/>
          </a:p>
        </p:txBody>
      </p:sp>
      <p:cxnSp>
        <p:nvCxnSpPr>
          <p:cNvPr id="21" name="Gerade Verbindung 20"/>
          <p:cNvCxnSpPr/>
          <p:nvPr/>
        </p:nvCxnSpPr>
        <p:spPr>
          <a:xfrm flipH="1">
            <a:off x="4860952" y="4183612"/>
            <a:ext cx="43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feld 21"/>
          <p:cNvSpPr txBox="1"/>
          <p:nvPr/>
        </p:nvSpPr>
        <p:spPr>
          <a:xfrm>
            <a:off x="4807416" y="3958296"/>
            <a:ext cx="528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*</a:t>
            </a:r>
            <a:endParaRPr lang="en-GB" dirty="0"/>
          </a:p>
        </p:txBody>
      </p:sp>
      <p:cxnSp>
        <p:nvCxnSpPr>
          <p:cNvPr id="24" name="Gerade Verbindung 23"/>
          <p:cNvCxnSpPr/>
          <p:nvPr/>
        </p:nvCxnSpPr>
        <p:spPr>
          <a:xfrm flipH="1">
            <a:off x="4860952" y="3407715"/>
            <a:ext cx="15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feld 24"/>
          <p:cNvSpPr txBox="1"/>
          <p:nvPr/>
        </p:nvSpPr>
        <p:spPr>
          <a:xfrm>
            <a:off x="5165063" y="3184680"/>
            <a:ext cx="5287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*</a:t>
            </a:r>
            <a:endParaRPr lang="en-GB" dirty="0"/>
          </a:p>
        </p:txBody>
      </p:sp>
      <p:sp>
        <p:nvSpPr>
          <p:cNvPr id="20" name="Textfeld 19"/>
          <p:cNvSpPr txBox="1"/>
          <p:nvPr/>
        </p:nvSpPr>
        <p:spPr>
          <a:xfrm>
            <a:off x="1607147" y="5026967"/>
            <a:ext cx="7315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2135875" y="5026967"/>
            <a:ext cx="7315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MP-9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2664603" y="5026967"/>
            <a:ext cx="7315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3193332" y="4942329"/>
            <a:ext cx="73151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MP-9 +LPS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>
            <a:extLst>
              <a:ext uri="{FF2B5EF4-FFF2-40B4-BE49-F238E27FC236}">
                <a16:creationId xmlns="" xmlns:a16="http://schemas.microsoft.com/office/drawing/2014/main" id="{115F94CB-B39B-449E-839F-2C99EFB1F11C}"/>
              </a:ext>
            </a:extLst>
          </p:cNvPr>
          <p:cNvSpPr txBox="1"/>
          <p:nvPr/>
        </p:nvSpPr>
        <p:spPr>
          <a:xfrm>
            <a:off x="1115261" y="2919224"/>
            <a:ext cx="45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A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="" xmlns:a16="http://schemas.microsoft.com/office/drawing/2014/main" id="{115F94CB-B39B-449E-839F-2C99EFB1F11C}"/>
              </a:ext>
            </a:extLst>
          </p:cNvPr>
          <p:cNvSpPr txBox="1"/>
          <p:nvPr/>
        </p:nvSpPr>
        <p:spPr>
          <a:xfrm>
            <a:off x="3943320" y="2919224"/>
            <a:ext cx="4517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B</a:t>
            </a:r>
          </a:p>
        </p:txBody>
      </p:sp>
      <p:sp>
        <p:nvSpPr>
          <p:cNvPr id="30" name="Rechteck 29"/>
          <p:cNvSpPr/>
          <p:nvPr/>
        </p:nvSpPr>
        <p:spPr>
          <a:xfrm>
            <a:off x="71992" y="5720769"/>
            <a:ext cx="8964503" cy="5924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nergistic effect of BMP-9 and LPS on LSEC </a:t>
            </a:r>
            <a:r>
              <a:rPr lang="en-US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pillarization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rker expression</a:t>
            </a:r>
            <a:r>
              <a:rPr lang="en-GB" sz="1100" b="1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. </a:t>
            </a:r>
            <a:r>
              <a:rPr lang="en-GB" sz="11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Human </a:t>
            </a:r>
            <a:r>
              <a:rPr lang="en-GB" sz="1100" dirty="0">
                <a:solidFill>
                  <a:srgbClr val="000000"/>
                </a:solidFill>
                <a:latin typeface="Times New Roman"/>
                <a:ea typeface="Times New Roman"/>
              </a:rPr>
              <a:t>LSEC were pre-cultured with or without BMP-9 (5 ng/ml) for 24h followed by addition of LPS (100 ng/ml) for another </a:t>
            </a:r>
            <a:r>
              <a:rPr lang="en-GB" sz="11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24h. Expression </a:t>
            </a:r>
            <a:r>
              <a:rPr lang="en-GB" sz="1100" dirty="0">
                <a:solidFill>
                  <a:srgbClr val="000000"/>
                </a:solidFill>
                <a:latin typeface="Times New Roman"/>
                <a:ea typeface="Times New Roman"/>
              </a:rPr>
              <a:t>levels of </a:t>
            </a:r>
            <a:r>
              <a:rPr lang="en-GB" sz="11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the LSEC differentiation marker lyve1 (A) and the </a:t>
            </a:r>
            <a:r>
              <a:rPr lang="en-GB" sz="1100" dirty="0" err="1" smtClean="0">
                <a:solidFill>
                  <a:srgbClr val="000000"/>
                </a:solidFill>
                <a:latin typeface="Times New Roman"/>
                <a:ea typeface="Times New Roman"/>
              </a:rPr>
              <a:t>capillarization</a:t>
            </a:r>
            <a:r>
              <a:rPr lang="en-GB" sz="11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 marker collagen type IV (col4a1) (B) were determined </a:t>
            </a:r>
            <a:r>
              <a:rPr lang="en-GB" sz="1100" dirty="0">
                <a:solidFill>
                  <a:srgbClr val="000000"/>
                </a:solidFill>
                <a:latin typeface="Times New Roman"/>
                <a:ea typeface="Times New Roman"/>
              </a:rPr>
              <a:t>by </a:t>
            </a:r>
            <a:r>
              <a:rPr lang="en-GB" sz="1100" dirty="0" smtClean="0">
                <a:solidFill>
                  <a:srgbClr val="000000"/>
                </a:solidFill>
                <a:latin typeface="Times New Roman"/>
                <a:ea typeface="Times New Roman"/>
              </a:rPr>
              <a:t>RT-qPCR as described for Fig. 3.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60582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</Words>
  <Application>Microsoft Office PowerPoint</Application>
  <PresentationFormat>Bildschirmpräsentation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-heidelberg.d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reitkopf, Katja</dc:creator>
  <cp:lastModifiedBy>Breitkopf, Katja</cp:lastModifiedBy>
  <cp:revision>6</cp:revision>
  <dcterms:created xsi:type="dcterms:W3CDTF">2019-11-29T10:17:58Z</dcterms:created>
  <dcterms:modified xsi:type="dcterms:W3CDTF">2020-02-24T13:14:37Z</dcterms:modified>
</cp:coreProperties>
</file>